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5" d="100"/>
          <a:sy n="85" d="100"/>
        </p:scale>
        <p:origin x="286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9600209980207948"/>
          <c:y val="3.576189245074872E-2"/>
          <c:w val="0.64994218450355523"/>
          <c:h val="0.8506266558414887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NT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1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C$1</c:f>
              <c:strCache>
                <c:ptCount val="2"/>
                <c:pt idx="0">
                  <c:v>0 gray</c:v>
                </c:pt>
                <c:pt idx="1">
                  <c:v>1 gray</c:v>
                </c:pt>
              </c:strCache>
            </c:strRef>
          </c:cat>
          <c:val>
            <c:numRef>
              <c:f>Sheet1!$B$2:$C$2</c:f>
              <c:numCache>
                <c:formatCode>General</c:formatCode>
                <c:ptCount val="2"/>
                <c:pt idx="0">
                  <c:v>2.5</c:v>
                </c:pt>
                <c:pt idx="1">
                  <c:v>45</c:v>
                </c:pt>
              </c:numCache>
            </c:numRef>
          </c:val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Ctrl si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1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C$1</c:f>
              <c:strCache>
                <c:ptCount val="2"/>
                <c:pt idx="0">
                  <c:v>0 gray</c:v>
                </c:pt>
                <c:pt idx="1">
                  <c:v>1 gray</c:v>
                </c:pt>
              </c:strCache>
            </c:strRef>
          </c:cat>
          <c:val>
            <c:numRef>
              <c:f>Sheet1!$B$3:$C$3</c:f>
              <c:numCache>
                <c:formatCode>General</c:formatCode>
                <c:ptCount val="2"/>
                <c:pt idx="0">
                  <c:v>2.5</c:v>
                </c:pt>
                <c:pt idx="1">
                  <c:v>47</c:v>
                </c:pt>
              </c:numCache>
            </c:numRef>
          </c:val>
        </c:ser>
        <c:ser>
          <c:idx val="2"/>
          <c:order val="2"/>
          <c:tx>
            <c:strRef>
              <c:f>Sheet1!$A$4</c:f>
              <c:strCache>
                <c:ptCount val="1"/>
                <c:pt idx="0">
                  <c:v>CX3CR1 si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1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:$C$1</c:f>
              <c:strCache>
                <c:ptCount val="2"/>
                <c:pt idx="0">
                  <c:v>0 gray</c:v>
                </c:pt>
                <c:pt idx="1">
                  <c:v>1 gray</c:v>
                </c:pt>
              </c:strCache>
            </c:strRef>
          </c:cat>
          <c:val>
            <c:numRef>
              <c:f>Sheet1!$B$4:$C$4</c:f>
              <c:numCache>
                <c:formatCode>General</c:formatCode>
                <c:ptCount val="2"/>
                <c:pt idx="0">
                  <c:v>2.5</c:v>
                </c:pt>
                <c:pt idx="1">
                  <c:v>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9190000"/>
        <c:axId val="329195040"/>
      </c:barChart>
      <c:catAx>
        <c:axId val="329190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9195040"/>
        <c:crosses val="autoZero"/>
        <c:auto val="1"/>
        <c:lblAlgn val="ctr"/>
        <c:lblOffset val="100"/>
        <c:noMultiLvlLbl val="0"/>
      </c:catAx>
      <c:valAx>
        <c:axId val="3291950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dirty="0">
                    <a:solidFill>
                      <a:schemeClr val="tx1"/>
                    </a:solidFill>
                  </a:rPr>
                  <a:t>Average number of </a:t>
                </a:r>
                <a:r>
                  <a:rPr lang="en-US" dirty="0" smtClean="0">
                    <a:solidFill>
                      <a:schemeClr val="tx1"/>
                    </a:solidFill>
                  </a:rPr>
                  <a:t>foci</a:t>
                </a:r>
                <a:r>
                  <a:rPr lang="en-US" baseline="0" dirty="0" smtClean="0">
                    <a:solidFill>
                      <a:schemeClr val="tx1"/>
                    </a:solidFill>
                  </a:rPr>
                  <a:t> </a:t>
                </a:r>
                <a:r>
                  <a:rPr lang="en-US" dirty="0" smtClean="0">
                    <a:solidFill>
                      <a:schemeClr val="tx1"/>
                    </a:solidFill>
                  </a:rPr>
                  <a:t>per </a:t>
                </a:r>
                <a:r>
                  <a:rPr lang="en-US" dirty="0">
                    <a:solidFill>
                      <a:schemeClr val="tx1"/>
                    </a:solidFill>
                  </a:rPr>
                  <a:t>cell</a:t>
                </a:r>
              </a:p>
            </c:rich>
          </c:tx>
          <c:layout>
            <c:manualLayout>
              <c:xMode val="edge"/>
              <c:yMode val="edge"/>
              <c:x val="2.7227433630411184E-2"/>
              <c:y val="0.1559369902074473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9190000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22440546988983134"/>
          <c:y val="3.3136736410445594E-2"/>
          <c:w val="0.49093357035712615"/>
          <c:h val="0.2400815819273956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628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45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291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4451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0809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2604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7789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43782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9991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9982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2310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189A0D-FA4C-4DD7-95B5-04EF16D5918A}" type="datetimeFigureOut">
              <a:rPr lang="en-US" smtClean="0"/>
              <a:t>2/1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4064EA-E90B-4BDC-B481-4936FCFE908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3941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1.png"/><Relationship Id="rId18" Type="http://schemas.microsoft.com/office/2007/relationships/hdphoto" Target="../media/hdphoto2.wdp"/><Relationship Id="rId26" Type="http://schemas.openxmlformats.org/officeDocument/2006/relationships/image" Target="../media/image19.png"/><Relationship Id="rId3" Type="http://schemas.openxmlformats.org/officeDocument/2006/relationships/image" Target="../media/image1.jpeg"/><Relationship Id="rId21" Type="http://schemas.openxmlformats.org/officeDocument/2006/relationships/image" Target="../media/image16.png"/><Relationship Id="rId34" Type="http://schemas.microsoft.com/office/2007/relationships/hdphoto" Target="../media/hdphoto7.wdp"/><Relationship Id="rId7" Type="http://schemas.openxmlformats.org/officeDocument/2006/relationships/image" Target="../media/image5.jpeg"/><Relationship Id="rId12" Type="http://schemas.openxmlformats.org/officeDocument/2006/relationships/image" Target="../media/image10.png"/><Relationship Id="rId17" Type="http://schemas.openxmlformats.org/officeDocument/2006/relationships/image" Target="../media/image14.png"/><Relationship Id="rId25" Type="http://schemas.microsoft.com/office/2007/relationships/hdphoto" Target="../media/hdphoto5.wdp"/><Relationship Id="rId33" Type="http://schemas.openxmlformats.org/officeDocument/2006/relationships/image" Target="../media/image25.png"/><Relationship Id="rId2" Type="http://schemas.openxmlformats.org/officeDocument/2006/relationships/chart" Target="../charts/chart1.xml"/><Relationship Id="rId16" Type="http://schemas.microsoft.com/office/2007/relationships/hdphoto" Target="../media/hdphoto1.wdp"/><Relationship Id="rId20" Type="http://schemas.microsoft.com/office/2007/relationships/hdphoto" Target="../media/hdphoto3.wdp"/><Relationship Id="rId29" Type="http://schemas.openxmlformats.org/officeDocument/2006/relationships/image" Target="../media/image2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png"/><Relationship Id="rId24" Type="http://schemas.openxmlformats.org/officeDocument/2006/relationships/image" Target="../media/image18.png"/><Relationship Id="rId32" Type="http://schemas.openxmlformats.org/officeDocument/2006/relationships/image" Target="../media/image24.png"/><Relationship Id="rId5" Type="http://schemas.openxmlformats.org/officeDocument/2006/relationships/image" Target="../media/image3.jpeg"/><Relationship Id="rId15" Type="http://schemas.openxmlformats.org/officeDocument/2006/relationships/image" Target="../media/image13.png"/><Relationship Id="rId23" Type="http://schemas.openxmlformats.org/officeDocument/2006/relationships/image" Target="../media/image17.png"/><Relationship Id="rId28" Type="http://schemas.openxmlformats.org/officeDocument/2006/relationships/image" Target="../media/image21.png"/><Relationship Id="rId36" Type="http://schemas.microsoft.com/office/2007/relationships/hdphoto" Target="../media/hdphoto8.wdp"/><Relationship Id="rId10" Type="http://schemas.openxmlformats.org/officeDocument/2006/relationships/image" Target="../media/image8.png"/><Relationship Id="rId19" Type="http://schemas.openxmlformats.org/officeDocument/2006/relationships/image" Target="../media/image15.png"/><Relationship Id="rId31" Type="http://schemas.openxmlformats.org/officeDocument/2006/relationships/image" Target="../media/image23.png"/><Relationship Id="rId4" Type="http://schemas.openxmlformats.org/officeDocument/2006/relationships/image" Target="../media/image2.jpeg"/><Relationship Id="rId9" Type="http://schemas.openxmlformats.org/officeDocument/2006/relationships/image" Target="../media/image7.png"/><Relationship Id="rId14" Type="http://schemas.openxmlformats.org/officeDocument/2006/relationships/image" Target="../media/image12.jpeg"/><Relationship Id="rId22" Type="http://schemas.microsoft.com/office/2007/relationships/hdphoto" Target="../media/hdphoto4.wdp"/><Relationship Id="rId27" Type="http://schemas.openxmlformats.org/officeDocument/2006/relationships/image" Target="../media/image20.png"/><Relationship Id="rId30" Type="http://schemas.microsoft.com/office/2007/relationships/hdphoto" Target="../media/hdphoto6.wdp"/><Relationship Id="rId35" Type="http://schemas.openxmlformats.org/officeDocument/2006/relationships/image" Target="../media/image26.png"/><Relationship Id="rId8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0" y="-5136"/>
            <a:ext cx="669431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Xie et al, Supplementary Figur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oup 28"/>
          <p:cNvGrpSpPr>
            <a:grpSpLocks noChangeAspect="1"/>
          </p:cNvGrpSpPr>
          <p:nvPr/>
        </p:nvGrpSpPr>
        <p:grpSpPr>
          <a:xfrm>
            <a:off x="4481074" y="816539"/>
            <a:ext cx="2114485" cy="1984263"/>
            <a:chOff x="7945005" y="839096"/>
            <a:chExt cx="4080603" cy="3829288"/>
          </a:xfrm>
        </p:grpSpPr>
        <p:graphicFrame>
          <p:nvGraphicFramePr>
            <p:cNvPr id="17" name="Chart 16"/>
            <p:cNvGraphicFramePr/>
            <p:nvPr>
              <p:extLst>
                <p:ext uri="{D42A27DB-BD31-4B8C-83A1-F6EECF244321}">
                  <p14:modId xmlns:p14="http://schemas.microsoft.com/office/powerpoint/2010/main" val="3246694496"/>
                </p:ext>
              </p:extLst>
            </p:nvPr>
          </p:nvGraphicFramePr>
          <p:xfrm>
            <a:off x="7945005" y="839096"/>
            <a:ext cx="4080603" cy="38292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18" name="Right Bracket 17"/>
            <p:cNvSpPr/>
            <p:nvPr/>
          </p:nvSpPr>
          <p:spPr>
            <a:xfrm rot="16200000">
              <a:off x="11274289" y="1158928"/>
              <a:ext cx="45720" cy="360356"/>
            </a:xfrm>
            <a:prstGeom prst="righ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0" y="193192"/>
            <a:ext cx="327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6000543" y="913292"/>
            <a:ext cx="4638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3" name="Group 32"/>
          <p:cNvGrpSpPr/>
          <p:nvPr/>
        </p:nvGrpSpPr>
        <p:grpSpPr>
          <a:xfrm>
            <a:off x="-49477" y="618969"/>
            <a:ext cx="4229672" cy="2195271"/>
            <a:chOff x="-49477" y="618969"/>
            <a:chExt cx="4229672" cy="2195271"/>
          </a:xfrm>
        </p:grpSpPr>
        <p:grpSp>
          <p:nvGrpSpPr>
            <p:cNvPr id="28" name="Group 27"/>
            <p:cNvGrpSpPr>
              <a:grpSpLocks noChangeAspect="1"/>
            </p:cNvGrpSpPr>
            <p:nvPr/>
          </p:nvGrpSpPr>
          <p:grpSpPr>
            <a:xfrm>
              <a:off x="303835" y="868136"/>
              <a:ext cx="3876360" cy="1946104"/>
              <a:chOff x="303823" y="868114"/>
              <a:chExt cx="7600708" cy="3815890"/>
            </a:xfrm>
          </p:grpSpPr>
          <p:pic>
            <p:nvPicPr>
              <p:cNvPr id="6" name="Picture 2" descr="C:\Users\jxie8\Desktop\02102015\caov3 0 nt 1\caov3 0 nt 1_(c1+c2)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3823" y="868149"/>
                <a:ext cx="2516324" cy="188559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7" name="Picture 2" descr="C:\Users\jxie8\Desktop\02102015\02112015\caov3 0 cx new\caov3 0 cx new_(c1+c2).JPG"/>
              <p:cNvPicPr>
                <a:picLocks noChangeAspect="1"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380484" y="868149"/>
                <a:ext cx="2516324" cy="188559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8" name="Picture 3" descr="C:\Users\jxie8\Desktop\02102015\02112015\caov3 1 nt new\caov3 1 nt new_(c1+c2).JPG"/>
              <p:cNvPicPr>
                <a:picLocks noChangeAspect="1"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3823" y="2794676"/>
                <a:ext cx="2516324" cy="188559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" name="Picture 4" descr="C:\Users\jxie8\Desktop\02102015\02112015\caov3 1 ctrl new 1\caov3 1 ctrl new 1_(c1+c2).JPG"/>
              <p:cNvPicPr>
                <a:picLocks noChangeAspect="1"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48724" y="2798414"/>
                <a:ext cx="2516324" cy="188559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" name="Picture 5" descr="C:\Users\jxie8\Desktop\02102015\02112015\caov3 1 cx new\caov3 1 cx new_(c1+c2).JPG"/>
              <p:cNvPicPr>
                <a:picLocks noChangeAspect="1" noChangeArrowheads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380483" y="2788888"/>
                <a:ext cx="2524048" cy="189137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1" name="Picture 10"/>
              <p:cNvPicPr>
                <a:picLocks noChangeAspect="1" noChangeArrowheads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48724" y="868149"/>
                <a:ext cx="2516538" cy="18855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" name="Picture 11"/>
              <p:cNvPicPr>
                <a:picLocks noChangeAspect="1" noChangeArrowheads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50621" y="869424"/>
                <a:ext cx="908058" cy="949334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3" name="Picture 12"/>
              <p:cNvPicPr>
                <a:picLocks noChangeAspect="1"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378207" y="868126"/>
                <a:ext cx="1112237" cy="949334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4" name="Picture 13"/>
              <p:cNvPicPr>
                <a:picLocks noChangeAspect="1"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3823" y="2794677"/>
                <a:ext cx="855255" cy="937007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5" name="Picture 14"/>
              <p:cNvPicPr>
                <a:picLocks noChangeAspect="1"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48725" y="2800914"/>
                <a:ext cx="915773" cy="944754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pic>
            <p:nvPicPr>
              <p:cNvPr id="16" name="Picture 15"/>
              <p:cNvPicPr>
                <a:picLocks noChangeAspect="1"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387127" y="2791389"/>
                <a:ext cx="840880" cy="944754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</p:pic>
          <p:sp>
            <p:nvSpPr>
              <p:cNvPr id="21" name="Rectangle 20"/>
              <p:cNvSpPr/>
              <p:nvPr/>
            </p:nvSpPr>
            <p:spPr>
              <a:xfrm>
                <a:off x="1163045" y="3393160"/>
                <a:ext cx="215242" cy="267629"/>
              </a:xfrm>
              <a:prstGeom prst="rect">
                <a:avLst/>
              </a:prstGeom>
              <a:noFill/>
              <a:ln w="3175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4590834" y="3548938"/>
                <a:ext cx="253256" cy="308119"/>
              </a:xfrm>
              <a:prstGeom prst="rect">
                <a:avLst/>
              </a:prstGeom>
              <a:noFill/>
              <a:ln w="3175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6358465" y="3231912"/>
                <a:ext cx="251976" cy="309132"/>
              </a:xfrm>
              <a:prstGeom prst="rect">
                <a:avLst/>
              </a:prstGeom>
              <a:noFill/>
              <a:ln w="3175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5673428" y="2250828"/>
                <a:ext cx="307493" cy="309132"/>
              </a:xfrm>
              <a:prstGeom prst="rect">
                <a:avLst/>
              </a:prstGeom>
              <a:noFill/>
              <a:ln w="3175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4436595" y="2254033"/>
                <a:ext cx="229075" cy="274707"/>
              </a:xfrm>
              <a:prstGeom prst="rect">
                <a:avLst/>
              </a:prstGeom>
              <a:noFill/>
              <a:ln w="3175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Rectangle 25"/>
              <p:cNvSpPr/>
              <p:nvPr/>
            </p:nvSpPr>
            <p:spPr>
              <a:xfrm rot="5400000">
                <a:off x="1921092" y="2048768"/>
                <a:ext cx="215242" cy="267629"/>
              </a:xfrm>
              <a:prstGeom prst="rect">
                <a:avLst/>
              </a:prstGeom>
              <a:noFill/>
              <a:ln w="3175">
                <a:solidFill>
                  <a:schemeClr val="bg1"/>
                </a:solidFill>
                <a:prstDash val="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pic>
            <p:nvPicPr>
              <p:cNvPr id="27" name="Picture 2" descr="C:\Users\jxie8\Desktop\02102015\caov3 0 nt 1\caov3 0 nt 1_(c1+c2).JPG"/>
              <p:cNvPicPr>
                <a:picLocks noChangeAspect="1" noChangeArrowheads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3764" t="64324" r="25777" b="23138"/>
              <a:stretch/>
            </p:blipFill>
            <p:spPr bwMode="auto">
              <a:xfrm>
                <a:off x="306663" y="868114"/>
                <a:ext cx="835243" cy="750462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31" name="TextBox 30"/>
            <p:cNvSpPr txBox="1"/>
            <p:nvPr/>
          </p:nvSpPr>
          <p:spPr>
            <a:xfrm>
              <a:off x="756357" y="618969"/>
              <a:ext cx="334151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                            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             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 rot="16200000">
              <a:off x="-825911" y="1632712"/>
              <a:ext cx="195297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x-ray radiation, gray</a:t>
              </a:r>
            </a:p>
            <a:p>
              <a:pPr algn="ctr"/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                    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8" name="TextBox 57"/>
          <p:cNvSpPr txBox="1"/>
          <p:nvPr/>
        </p:nvSpPr>
        <p:spPr>
          <a:xfrm>
            <a:off x="14265" y="3117299"/>
            <a:ext cx="327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312530" y="3147454"/>
            <a:ext cx="3277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/>
          <p:cNvGrpSpPr/>
          <p:nvPr/>
        </p:nvGrpSpPr>
        <p:grpSpPr>
          <a:xfrm>
            <a:off x="-28122" y="3081591"/>
            <a:ext cx="7315675" cy="5625724"/>
            <a:chOff x="-28122" y="3589596"/>
            <a:chExt cx="7315675" cy="5625724"/>
          </a:xfrm>
        </p:grpSpPr>
        <p:sp>
          <p:nvSpPr>
            <p:cNvPr id="99" name="TextBox 98"/>
            <p:cNvSpPr txBox="1"/>
            <p:nvPr/>
          </p:nvSpPr>
          <p:spPr>
            <a:xfrm rot="18538241">
              <a:off x="4180865" y="4077161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 rot="18538241">
              <a:off x="4480060" y="4092973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 rot="18538241">
              <a:off x="890154" y="4071518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 rot="18538241">
              <a:off x="267366" y="4087330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 rot="18538241">
              <a:off x="591847" y="4103141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-28122" y="4111577"/>
              <a:ext cx="114847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ov-3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6" name="Picture 2"/>
            <p:cNvPicPr preferRelativeResize="0">
              <a:picLocks noChangeArrowheads="1"/>
            </p:cNvPicPr>
            <p:nvPr/>
          </p:nvPicPr>
          <p:blipFill rotWithShape="1">
            <a:blip r:embed="rId15" cstate="print">
              <a:extLst>
                <a:ext uri="{BEBA8EAE-BF5A-486C-A8C5-ECC9F3942E4B}">
                  <a14:imgProps xmlns:a14="http://schemas.microsoft.com/office/drawing/2010/main">
                    <a14:imgLayer r:embed="rId1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727" b="16725"/>
            <a:stretch/>
          </p:blipFill>
          <p:spPr bwMode="auto">
            <a:xfrm>
              <a:off x="27481" y="5688751"/>
              <a:ext cx="1934162" cy="31532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7" name="Picture 2"/>
            <p:cNvPicPr preferRelativeResize="0">
              <a:picLocks noChangeArrowheads="1"/>
            </p:cNvPicPr>
            <p:nvPr/>
          </p:nvPicPr>
          <p:blipFill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481" y="6093483"/>
              <a:ext cx="1934162" cy="31532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8" name="Picture 4"/>
            <p:cNvPicPr preferRelativeResize="0">
              <a:picLocks noChangeArrowheads="1"/>
            </p:cNvPicPr>
            <p:nvPr/>
          </p:nvPicPr>
          <p:blipFill>
            <a:blip r:embed="rId19">
              <a:extLst>
                <a:ext uri="{BEBA8EAE-BF5A-486C-A8C5-ECC9F3942E4B}">
                  <a14:imgProps xmlns:a14="http://schemas.microsoft.com/office/drawing/2010/main">
                    <a14:imgLayer r:embed="rId20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980" y="5262076"/>
              <a:ext cx="1934162" cy="31161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39" name="Picture 38"/>
            <p:cNvPicPr preferRelativeResize="0">
              <a:picLocks noChangeArrowheads="1"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>
                    <a14:imgLayer r:embed="rId22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481" y="6503161"/>
              <a:ext cx="1934162" cy="31532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40" name="Picture 10"/>
            <p:cNvPicPr preferRelativeResize="0">
              <a:picLocks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980" y="4860690"/>
              <a:ext cx="1934162" cy="31532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41" name="TextBox 40"/>
            <p:cNvSpPr txBox="1"/>
            <p:nvPr/>
          </p:nvSpPr>
          <p:spPr>
            <a:xfrm>
              <a:off x="1906580" y="5706699"/>
              <a:ext cx="19908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CHEK2 T68 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1917869" y="4855070"/>
              <a:ext cx="17944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TM S1981 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1909111" y="6524192"/>
              <a:ext cx="192912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BB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1909111" y="6119460"/>
              <a:ext cx="1929126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CHEK2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1927776" y="5280024"/>
              <a:ext cx="1673466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ATM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/>
            <p:cNvSpPr txBox="1"/>
            <p:nvPr/>
          </p:nvSpPr>
          <p:spPr>
            <a:xfrm rot="18538241">
              <a:off x="-74761" y="4071518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-20864" y="6962168"/>
              <a:ext cx="1102791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gray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944836" y="6960891"/>
              <a:ext cx="1102791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 gray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 rot="18538241">
              <a:off x="1189349" y="4087330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 rot="18538241">
              <a:off x="1536900" y="4103141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Left Bracket 55"/>
            <p:cNvSpPr/>
            <p:nvPr/>
          </p:nvSpPr>
          <p:spPr>
            <a:xfrm rot="16200000">
              <a:off x="469020" y="6439108"/>
              <a:ext cx="86878" cy="94695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2" name="Picture 2"/>
            <p:cNvPicPr preferRelativeResize="0">
              <a:picLocks noChangeArrowheads="1"/>
            </p:cNvPicPr>
            <p:nvPr/>
          </p:nvPicPr>
          <p:blipFill>
            <a:blip r:embed="rId24">
              <a:extLst>
                <a:ext uri="{BEBA8EAE-BF5A-486C-A8C5-ECC9F3942E4B}">
                  <a14:imgProps xmlns:a14="http://schemas.microsoft.com/office/drawing/2010/main">
                    <a14:imgLayer r:embed="rId25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97839" y="4847348"/>
              <a:ext cx="1984766" cy="34354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3" name="Picture 6"/>
            <p:cNvPicPr preferRelativeResize="0">
              <a:picLocks noChangeArrowheads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97391" y="6142085"/>
              <a:ext cx="1985018" cy="34333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4" name="Picture 6"/>
            <p:cNvPicPr preferRelativeResize="0">
              <a:picLocks noChangeArrowheads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97391" y="5727373"/>
              <a:ext cx="1984766" cy="34354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5" name="Picture 10"/>
            <p:cNvPicPr preferRelativeResize="0">
              <a:picLocks noChangeArrowheads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97391" y="6617933"/>
              <a:ext cx="1984766" cy="34354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6" name="Picture 11"/>
            <p:cNvPicPr preferRelativeResize="0">
              <a:picLocks noChangeArrowheads="1"/>
            </p:cNvPicPr>
            <p:nvPr/>
          </p:nvPicPr>
          <p:blipFill rotWithShape="1">
            <a:blip r:embed="rId29">
              <a:extLst>
                <a:ext uri="{BEBA8EAE-BF5A-486C-A8C5-ECC9F3942E4B}">
                  <a14:imgProps xmlns:a14="http://schemas.microsoft.com/office/drawing/2010/main">
                    <a14:imgLayer r:embed="rId30">
                      <a14:imgEffect>
                        <a14:brightnessContrast bright="18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0547"/>
            <a:stretch/>
          </p:blipFill>
          <p:spPr bwMode="auto">
            <a:xfrm>
              <a:off x="3298432" y="7500324"/>
              <a:ext cx="1984766" cy="34354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7" name="Picture 12"/>
            <p:cNvPicPr preferRelativeResize="0">
              <a:picLocks noChangeArrowheads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97839" y="7038677"/>
              <a:ext cx="1984766" cy="34354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8" name="Picture 13"/>
            <p:cNvPicPr preferRelativeResize="0">
              <a:picLocks noChangeArrowheads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98432" y="5256802"/>
              <a:ext cx="1984766" cy="34354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69" name="TextBox 68"/>
            <p:cNvSpPr txBox="1"/>
            <p:nvPr/>
          </p:nvSpPr>
          <p:spPr>
            <a:xfrm>
              <a:off x="3203750" y="4092214"/>
              <a:ext cx="10759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KOV-3 </a:t>
              </a:r>
              <a:endParaRPr lang="zh-CN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0" name="Picture 4"/>
            <p:cNvPicPr preferRelativeResize="0">
              <a:picLocks noChangeArrowheads="1"/>
            </p:cNvPicPr>
            <p:nvPr/>
          </p:nvPicPr>
          <p:blipFill>
            <a:blip r:embed="rId33" cstate="print">
              <a:extLst>
                <a:ext uri="{BEBA8EAE-BF5A-486C-A8C5-ECC9F3942E4B}">
                  <a14:imgProps xmlns:a14="http://schemas.microsoft.com/office/drawing/2010/main">
                    <a14:imgLayer r:embed="rId3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98208" y="8337815"/>
              <a:ext cx="1985018" cy="34333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71" name="TextBox 70"/>
            <p:cNvSpPr txBox="1"/>
            <p:nvPr/>
          </p:nvSpPr>
          <p:spPr>
            <a:xfrm>
              <a:off x="5230625" y="4868954"/>
              <a:ext cx="155604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TM S1981 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237001" y="5283340"/>
              <a:ext cx="1455798" cy="382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ATM 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5230625" y="5756277"/>
              <a:ext cx="19065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CHEK1 S317 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237001" y="6187280"/>
              <a:ext cx="14557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CHEK1 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5237001" y="6655410"/>
              <a:ext cx="19567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ospho-CHEK2 T68 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5237001" y="7123540"/>
              <a:ext cx="1455798" cy="382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CHEK2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5234786" y="7561972"/>
              <a:ext cx="20527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PRKDC T2609 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234785" y="8380182"/>
              <a:ext cx="1791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BA1A 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9" name="Picture 3"/>
            <p:cNvPicPr preferRelativeResize="0">
              <a:picLocks noChangeArrowheads="1"/>
            </p:cNvPicPr>
            <p:nvPr/>
          </p:nvPicPr>
          <p:blipFill rotWithShape="1">
            <a:blip r:embed="rId35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-14343"/>
            <a:stretch/>
          </p:blipFill>
          <p:spPr bwMode="auto">
            <a:xfrm>
              <a:off x="3303495" y="7917071"/>
              <a:ext cx="1984766" cy="35208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80" name="TextBox 79"/>
            <p:cNvSpPr txBox="1"/>
            <p:nvPr/>
          </p:nvSpPr>
          <p:spPr>
            <a:xfrm>
              <a:off x="5234786" y="7970903"/>
              <a:ext cx="1791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otal PRKDC 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 rot="18538241">
              <a:off x="3558077" y="4092973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trl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 rot="18538241">
              <a:off x="3882558" y="4108784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 rot="18538241">
              <a:off x="3215950" y="4077161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TextBox 100"/>
            <p:cNvSpPr txBox="1"/>
            <p:nvPr/>
          </p:nvSpPr>
          <p:spPr>
            <a:xfrm rot="18538241">
              <a:off x="4827611" y="4108784"/>
              <a:ext cx="1372572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X</a:t>
              </a:r>
              <a:r>
                <a:rPr lang="en-US" sz="10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1 </a:t>
              </a:r>
              <a:r>
                <a:rPr lang="en-US" sz="10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Left Bracket 85"/>
            <p:cNvSpPr/>
            <p:nvPr/>
          </p:nvSpPr>
          <p:spPr>
            <a:xfrm rot="16200000">
              <a:off x="1445513" y="6433462"/>
              <a:ext cx="86878" cy="94695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258999" y="8806593"/>
              <a:ext cx="1102791" cy="4087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gray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4224699" y="8805316"/>
              <a:ext cx="110279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r>
                <a:rPr lang="en-US" altLang="zh-CN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gray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Left Bracket 88"/>
            <p:cNvSpPr/>
            <p:nvPr/>
          </p:nvSpPr>
          <p:spPr>
            <a:xfrm rot="16200000">
              <a:off x="3748883" y="8283533"/>
              <a:ext cx="86878" cy="94695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Left Bracket 89"/>
            <p:cNvSpPr/>
            <p:nvPr/>
          </p:nvSpPr>
          <p:spPr>
            <a:xfrm rot="16200000">
              <a:off x="4725376" y="8277887"/>
              <a:ext cx="86878" cy="946953"/>
            </a:xfrm>
            <a:prstGeom prst="leftBracket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3" name="TextBox 82"/>
          <p:cNvSpPr txBox="1"/>
          <p:nvPr/>
        </p:nvSpPr>
        <p:spPr>
          <a:xfrm>
            <a:off x="2976875" y="2337951"/>
            <a:ext cx="1253365" cy="60529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>
              <a:lnSpc>
                <a:spcPts val="1000"/>
              </a:lnSpc>
            </a:pPr>
            <a:r>
              <a:rPr lang="en-US" sz="1000" dirty="0" smtClean="0">
                <a:solidFill>
                  <a:srgbClr val="00999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en-US" sz="1000" dirty="0">
              <a:solidFill>
                <a:srgbClr val="0099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r">
              <a:lnSpc>
                <a:spcPts val="1000"/>
              </a:lnSpc>
            </a:pPr>
            <a:r>
              <a:rPr lang="en-US" sz="1000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  <a:p>
            <a:pPr algn="r">
              <a:lnSpc>
                <a:spcPts val="1000"/>
              </a:lnSpc>
            </a:pPr>
            <a:r>
              <a:rPr lang="en-US" sz="1000" dirty="0" err="1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TM</a:t>
            </a:r>
            <a:r>
              <a:rPr lang="en-US" sz="1000" dirty="0" smtClean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1981</a:t>
            </a:r>
          </a:p>
          <a:p>
            <a:pPr algn="r">
              <a:lnSpc>
                <a:spcPts val="1000"/>
              </a:lnSpc>
            </a:pPr>
            <a:endParaRPr lang="en-US" sz="1000" dirty="0">
              <a:solidFill>
                <a:srgbClr val="009999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 flipV="1">
            <a:off x="1115283" y="2697250"/>
            <a:ext cx="327539" cy="794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04573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0</TotalTime>
  <Words>88</Words>
  <Application>Microsoft Office PowerPoint</Application>
  <PresentationFormat>On-screen Show (4:3)</PresentationFormat>
  <Paragraphs>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rbolina, Maria</dc:creator>
  <cp:lastModifiedBy>Barbolina, Maria</cp:lastModifiedBy>
  <cp:revision>12</cp:revision>
  <dcterms:created xsi:type="dcterms:W3CDTF">2016-11-10T20:21:05Z</dcterms:created>
  <dcterms:modified xsi:type="dcterms:W3CDTF">2018-02-12T16:24:48Z</dcterms:modified>
</cp:coreProperties>
</file>